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99" r:id="rId2"/>
  </p:sldIdLst>
  <p:sldSz cx="6858000" cy="7315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FF"/>
    <a:srgbClr val="009AD0"/>
    <a:srgbClr val="8156B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01" autoAdjust="0"/>
    <p:restoredTop sz="94660"/>
  </p:normalViewPr>
  <p:slideViewPr>
    <p:cSldViewPr snapToGrid="0">
      <p:cViewPr varScale="1">
        <p:scale>
          <a:sx n="64" d="100"/>
          <a:sy n="64" d="100"/>
        </p:scale>
        <p:origin x="205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y%20Passport:All%20Desktop:Desktop%204:Dtergent%20screening%20JF-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hart>
    <c:autoTitleDeleted val="0"/>
    <c:plotArea>
      <c:layout>
        <c:manualLayout>
          <c:layoutTarget val="inner"/>
          <c:xMode val="edge"/>
          <c:yMode val="edge"/>
          <c:x val="5.6515434889726303E-2"/>
          <c:y val="4.4528101176260597E-2"/>
          <c:w val="0.67084414767711098"/>
          <c:h val="0.94211346847086097"/>
        </c:manualLayout>
      </c:layout>
      <c:scatterChart>
        <c:scatterStyle val="smoothMarker"/>
        <c:varyColors val="0"/>
        <c:ser>
          <c:idx val="1"/>
          <c:order val="0"/>
          <c:tx>
            <c:strRef>
              <c:f>Hoja2!$C$30</c:f>
              <c:strCache>
                <c:ptCount val="1"/>
                <c:pt idx="0">
                  <c:v>CHAPS</c:v>
                </c:pt>
              </c:strCache>
            </c:strRef>
          </c:tx>
          <c:marker>
            <c:symbol val="none"/>
          </c:marker>
          <c:xVal>
            <c:numRef>
              <c:f>Hoja2!$A$31:$A$57</c:f>
              <c:numCache>
                <c:formatCode>General</c:formatCode>
                <c:ptCount val="27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  <c:pt idx="6">
                  <c:v>1.2</c:v>
                </c:pt>
                <c:pt idx="7">
                  <c:v>1.4</c:v>
                </c:pt>
                <c:pt idx="8">
                  <c:v>1.6</c:v>
                </c:pt>
                <c:pt idx="9">
                  <c:v>1.8</c:v>
                </c:pt>
                <c:pt idx="10">
                  <c:v>2</c:v>
                </c:pt>
                <c:pt idx="11">
                  <c:v>2.2000000000000002</c:v>
                </c:pt>
                <c:pt idx="12">
                  <c:v>2.4</c:v>
                </c:pt>
                <c:pt idx="13">
                  <c:v>2.6</c:v>
                </c:pt>
                <c:pt idx="14">
                  <c:v>2.8</c:v>
                </c:pt>
                <c:pt idx="15">
                  <c:v>3</c:v>
                </c:pt>
                <c:pt idx="16">
                  <c:v>3.2</c:v>
                </c:pt>
                <c:pt idx="17">
                  <c:v>3.4</c:v>
                </c:pt>
                <c:pt idx="18">
                  <c:v>3.6</c:v>
                </c:pt>
                <c:pt idx="19">
                  <c:v>3.8</c:v>
                </c:pt>
                <c:pt idx="20">
                  <c:v>4</c:v>
                </c:pt>
                <c:pt idx="21">
                  <c:v>4.2</c:v>
                </c:pt>
                <c:pt idx="22">
                  <c:v>4.4000000000000004</c:v>
                </c:pt>
                <c:pt idx="23">
                  <c:v>4.5999999999999996</c:v>
                </c:pt>
                <c:pt idx="24">
                  <c:v>4.8</c:v>
                </c:pt>
                <c:pt idx="25">
                  <c:v>5</c:v>
                </c:pt>
                <c:pt idx="26">
                  <c:v>5.2</c:v>
                </c:pt>
              </c:numCache>
            </c:numRef>
          </c:xVal>
          <c:yVal>
            <c:numRef>
              <c:f>Hoja2!$C$31:$C$57</c:f>
              <c:numCache>
                <c:formatCode>General</c:formatCode>
                <c:ptCount val="27"/>
                <c:pt idx="0">
                  <c:v>-15.39714</c:v>
                </c:pt>
                <c:pt idx="1">
                  <c:v>-11.330120000000001</c:v>
                </c:pt>
                <c:pt idx="2">
                  <c:v>-7.2630999999999997</c:v>
                </c:pt>
                <c:pt idx="3">
                  <c:v>-3.1960799999999998</c:v>
                </c:pt>
                <c:pt idx="4">
                  <c:v>0.87094000000000005</c:v>
                </c:pt>
                <c:pt idx="5">
                  <c:v>4.9379600000000003</c:v>
                </c:pt>
                <c:pt idx="6">
                  <c:v>9.0049799999999998</c:v>
                </c:pt>
                <c:pt idx="7">
                  <c:v>13.071999999999999</c:v>
                </c:pt>
                <c:pt idx="8">
                  <c:v>23.989619999999999</c:v>
                </c:pt>
                <c:pt idx="9">
                  <c:v>29.847490000000001</c:v>
                </c:pt>
                <c:pt idx="10">
                  <c:v>56.243259999999999</c:v>
                </c:pt>
                <c:pt idx="11">
                  <c:v>143.20652000000001</c:v>
                </c:pt>
                <c:pt idx="12">
                  <c:v>381.50483999999989</c:v>
                </c:pt>
                <c:pt idx="13">
                  <c:v>510.93119999999902</c:v>
                </c:pt>
                <c:pt idx="14">
                  <c:v>356.36898000000002</c:v>
                </c:pt>
                <c:pt idx="15">
                  <c:v>178.50664</c:v>
                </c:pt>
                <c:pt idx="16">
                  <c:v>119.04430000000001</c:v>
                </c:pt>
                <c:pt idx="17">
                  <c:v>71.002960000000002</c:v>
                </c:pt>
                <c:pt idx="18">
                  <c:v>58.925690000000003</c:v>
                </c:pt>
                <c:pt idx="19">
                  <c:v>26.767990000000001</c:v>
                </c:pt>
                <c:pt idx="20">
                  <c:v>14.58577</c:v>
                </c:pt>
                <c:pt idx="21">
                  <c:v>8.8350600000000004</c:v>
                </c:pt>
                <c:pt idx="22">
                  <c:v>7.8942999999999977</c:v>
                </c:pt>
                <c:pt idx="23">
                  <c:v>3.7469066666666699</c:v>
                </c:pt>
                <c:pt idx="24">
                  <c:v>0.40117166666666698</c:v>
                </c:pt>
                <c:pt idx="25">
                  <c:v>-2.9445633333333299</c:v>
                </c:pt>
                <c:pt idx="26">
                  <c:v>-6.290298333333329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4CC3-4A33-A37B-950A173000CE}"/>
            </c:ext>
          </c:extLst>
        </c:ser>
        <c:ser>
          <c:idx val="3"/>
          <c:order val="1"/>
          <c:tx>
            <c:strRef>
              <c:f>Hoja2!$E$30</c:f>
              <c:strCache>
                <c:ptCount val="1"/>
                <c:pt idx="0">
                  <c:v>N-laurosylsarcosin</c:v>
                </c:pt>
              </c:strCache>
            </c:strRef>
          </c:tx>
          <c:marker>
            <c:symbol val="none"/>
          </c:marker>
          <c:xVal>
            <c:numRef>
              <c:f>Hoja2!$A$31:$A$57</c:f>
              <c:numCache>
                <c:formatCode>General</c:formatCode>
                <c:ptCount val="27"/>
                <c:pt idx="0">
                  <c:v>0</c:v>
                </c:pt>
                <c:pt idx="1">
                  <c:v>0.2</c:v>
                </c:pt>
                <c:pt idx="2">
                  <c:v>0.4</c:v>
                </c:pt>
                <c:pt idx="3">
                  <c:v>0.6</c:v>
                </c:pt>
                <c:pt idx="4">
                  <c:v>0.8</c:v>
                </c:pt>
                <c:pt idx="5">
                  <c:v>1</c:v>
                </c:pt>
                <c:pt idx="6">
                  <c:v>1.2</c:v>
                </c:pt>
                <c:pt idx="7">
                  <c:v>1.4</c:v>
                </c:pt>
                <c:pt idx="8">
                  <c:v>1.6</c:v>
                </c:pt>
                <c:pt idx="9">
                  <c:v>1.8</c:v>
                </c:pt>
                <c:pt idx="10">
                  <c:v>2</c:v>
                </c:pt>
                <c:pt idx="11">
                  <c:v>2.2000000000000002</c:v>
                </c:pt>
                <c:pt idx="12">
                  <c:v>2.4</c:v>
                </c:pt>
                <c:pt idx="13">
                  <c:v>2.6</c:v>
                </c:pt>
                <c:pt idx="14">
                  <c:v>2.8</c:v>
                </c:pt>
                <c:pt idx="15">
                  <c:v>3</c:v>
                </c:pt>
                <c:pt idx="16">
                  <c:v>3.2</c:v>
                </c:pt>
                <c:pt idx="17">
                  <c:v>3.4</c:v>
                </c:pt>
                <c:pt idx="18">
                  <c:v>3.6</c:v>
                </c:pt>
                <c:pt idx="19">
                  <c:v>3.8</c:v>
                </c:pt>
                <c:pt idx="20">
                  <c:v>4</c:v>
                </c:pt>
                <c:pt idx="21">
                  <c:v>4.2</c:v>
                </c:pt>
                <c:pt idx="22">
                  <c:v>4.4000000000000004</c:v>
                </c:pt>
                <c:pt idx="23">
                  <c:v>4.5999999999999996</c:v>
                </c:pt>
                <c:pt idx="24">
                  <c:v>4.8</c:v>
                </c:pt>
                <c:pt idx="25">
                  <c:v>5</c:v>
                </c:pt>
                <c:pt idx="26">
                  <c:v>5.2</c:v>
                </c:pt>
              </c:numCache>
            </c:numRef>
          </c:xVal>
          <c:yVal>
            <c:numRef>
              <c:f>Hoja2!$E$31:$E$57</c:f>
              <c:numCache>
                <c:formatCode>General</c:formatCode>
                <c:ptCount val="27"/>
                <c:pt idx="0">
                  <c:v>-4.3094599999999996</c:v>
                </c:pt>
                <c:pt idx="1">
                  <c:v>-7.0020600000000002</c:v>
                </c:pt>
                <c:pt idx="2">
                  <c:v>-9.6946600000000007</c:v>
                </c:pt>
                <c:pt idx="3">
                  <c:v>-12.387259999999999</c:v>
                </c:pt>
                <c:pt idx="4">
                  <c:v>-15.07986</c:v>
                </c:pt>
                <c:pt idx="5">
                  <c:v>-17.772459999999999</c:v>
                </c:pt>
                <c:pt idx="6">
                  <c:v>4.0572800000000004</c:v>
                </c:pt>
                <c:pt idx="7">
                  <c:v>115.88702000000001</c:v>
                </c:pt>
                <c:pt idx="8">
                  <c:v>920.37738999999999</c:v>
                </c:pt>
                <c:pt idx="9">
                  <c:v>487.22304000000003</c:v>
                </c:pt>
                <c:pt idx="10">
                  <c:v>170.34761</c:v>
                </c:pt>
                <c:pt idx="11">
                  <c:v>42.456479999999999</c:v>
                </c:pt>
                <c:pt idx="12">
                  <c:v>24.897279999999999</c:v>
                </c:pt>
                <c:pt idx="13">
                  <c:v>12.983140000000001</c:v>
                </c:pt>
                <c:pt idx="14">
                  <c:v>10.817780000000001</c:v>
                </c:pt>
                <c:pt idx="15">
                  <c:v>35.416780000000003</c:v>
                </c:pt>
                <c:pt idx="16">
                  <c:v>57.987990000000003</c:v>
                </c:pt>
                <c:pt idx="17">
                  <c:v>56.902839999999998</c:v>
                </c:pt>
                <c:pt idx="18">
                  <c:v>37.022730000000003</c:v>
                </c:pt>
                <c:pt idx="19">
                  <c:v>12.649369999999999</c:v>
                </c:pt>
                <c:pt idx="20">
                  <c:v>10.033670000000001</c:v>
                </c:pt>
                <c:pt idx="21">
                  <c:v>7.9884500000000003</c:v>
                </c:pt>
                <c:pt idx="22">
                  <c:v>5.9432299999999998</c:v>
                </c:pt>
                <c:pt idx="23">
                  <c:v>3.8980100000000002</c:v>
                </c:pt>
                <c:pt idx="24">
                  <c:v>1.8527899999999999</c:v>
                </c:pt>
                <c:pt idx="25">
                  <c:v>-0.19243000000000099</c:v>
                </c:pt>
                <c:pt idx="26">
                  <c:v>-2.23764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4CC3-4A33-A37B-950A173000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8910016"/>
        <c:axId val="578904528"/>
      </c:scatterChart>
      <c:valAx>
        <c:axId val="5789100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578904528"/>
        <c:crosses val="autoZero"/>
        <c:crossBetween val="midCat"/>
        <c:majorUnit val="0.5"/>
      </c:valAx>
      <c:valAx>
        <c:axId val="5789045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578910016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46370488287554973"/>
          <c:y val="0.28181887826700835"/>
          <c:w val="0.47243177877483961"/>
          <c:h val="0.17905305189089454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DD9BC3-A87F-4B2E-841D-BB48842DD1C1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82788" y="1143000"/>
            <a:ext cx="2892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DA84F7-CE3F-4B2D-81E5-3229BA54D3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995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1pPr>
    <a:lvl2pPr marL="190470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2pPr>
    <a:lvl3pPr marL="380939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3pPr>
    <a:lvl4pPr marL="571409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4pPr>
    <a:lvl5pPr marL="761878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5pPr>
    <a:lvl6pPr marL="952348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6pPr>
    <a:lvl7pPr marL="1142817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7pPr>
    <a:lvl8pPr marL="1333287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8pPr>
    <a:lvl9pPr marL="1523756" algn="l" defTabSz="380939" rtl="0" eaLnBrk="1" latinLnBrk="0" hangingPunct="1">
      <a:defRPr sz="5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197187"/>
            <a:ext cx="5829300" cy="254677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3842174"/>
            <a:ext cx="5143500" cy="176614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912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6643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389467"/>
            <a:ext cx="1478756" cy="619929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389467"/>
            <a:ext cx="4350544" cy="619929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126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921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823722"/>
            <a:ext cx="5915025" cy="30429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4895429"/>
            <a:ext cx="5915025" cy="16001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2996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1947333"/>
            <a:ext cx="2914650" cy="46414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1947333"/>
            <a:ext cx="2914650" cy="46414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967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389468"/>
            <a:ext cx="5915025" cy="14139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793241"/>
            <a:ext cx="2901255" cy="87883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672080"/>
            <a:ext cx="2901255" cy="39302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793241"/>
            <a:ext cx="2915543" cy="87883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672080"/>
            <a:ext cx="2915543" cy="393022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013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237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976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7680"/>
            <a:ext cx="2211884" cy="17068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053255"/>
            <a:ext cx="3471863" cy="519853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94560"/>
            <a:ext cx="2211884" cy="406569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773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7680"/>
            <a:ext cx="2211884" cy="170688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053255"/>
            <a:ext cx="3471863" cy="519853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194560"/>
            <a:ext cx="2211884" cy="406569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409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389468"/>
            <a:ext cx="5915025" cy="14139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1947333"/>
            <a:ext cx="5915025" cy="464142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6780108"/>
            <a:ext cx="154305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26B4C-DE86-4CEF-B3B0-7D4D61DA3787}" type="datetimeFigureOut">
              <a:rPr lang="en-US" smtClean="0"/>
              <a:t>12/1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6780108"/>
            <a:ext cx="2314575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6780108"/>
            <a:ext cx="154305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24905-4DE6-4BD4-A795-68D496357E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117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4071" y="110584"/>
            <a:ext cx="5776957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70301" y="373093"/>
            <a:ext cx="292068" cy="2717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74964" y="4025565"/>
            <a:ext cx="292068" cy="2717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748498" y="6035630"/>
            <a:ext cx="292068" cy="2717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8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1752637"/>
              </p:ext>
            </p:extLst>
          </p:nvPr>
        </p:nvGraphicFramePr>
        <p:xfrm>
          <a:off x="662369" y="416584"/>
          <a:ext cx="4053004" cy="3555795"/>
        </p:xfrm>
        <a:graphic>
          <a:graphicData uri="http://schemas.openxmlformats.org/drawingml/2006/table">
            <a:tbl>
              <a:tblPr/>
              <a:tblGrid>
                <a:gridCol w="135409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871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117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39898">
                <a:tc>
                  <a:txBody>
                    <a:bodyPr/>
                    <a:lstStyle/>
                    <a:p>
                      <a:pPr algn="l" fontAlgn="b"/>
                      <a:r>
                        <a:rPr lang="da-DK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ergent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MC (</a:t>
                      </a:r>
                      <a:r>
                        <a:rPr lang="es-E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</a:t>
                      </a:r>
                      <a:r>
                        <a:rPr lang="es-E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igomerization state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hr-H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ij3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id aggregates, high oligomers, some 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hr-H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ij98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 oligomers, some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oxyBIGCHAP</a:t>
                      </a:r>
                      <a:endParaRPr lang="es-E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CAMEG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d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GA-8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trimers, d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GA-9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trimers, d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GA-1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trimers, d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Octyl-D-glucopyranoside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rose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olaureat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w high oligomers, trimers, dimers, mono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ton X-10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id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regates</a:t>
                      </a:r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it-IT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  <a:endParaRPr lang="it-IT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ton X-114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id Aggregate,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dimer and monomer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een2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9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nl-N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ween8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2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nb-NO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idet P4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  <a:endParaRPr lang="es-ES_tradnl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Laurosylsarcosin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7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id aggregate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thiumdodecyl sulfate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id aggregate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pt-B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cholate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dium deoxycholate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t-IT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oid aggregate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D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, mono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P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me high oligomers and 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APSO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 oligomers and </a:t>
                      </a:r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lfobetaine SB10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lfobetaine SB12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_tradnl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lfobetaine SB14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mers, very little 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lfobetaine SB16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mers, very little trimers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pl-PL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mal</a:t>
                      </a:r>
                      <a:r>
                        <a:rPr lang="pl-PL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5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ttle high oligomers, </a:t>
                      </a:r>
                      <a:r>
                        <a:rPr lang="en-US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CFF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2811">
                <a:tc>
                  <a:txBody>
                    <a:bodyPr/>
                    <a:lstStyle/>
                    <a:p>
                      <a:pPr algn="l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DM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v-SE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</a:t>
                      </a:r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sv-SE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igomers</a:t>
                      </a:r>
                      <a:r>
                        <a:rPr lang="sv-SE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sv-SE" sz="7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mers</a:t>
                      </a:r>
                      <a:endParaRPr lang="sv-SE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556" marR="3556" marT="35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</a:tbl>
          </a:graphicData>
        </a:graphic>
      </p:graphicFrame>
      <p:graphicFrame>
        <p:nvGraphicFramePr>
          <p:cNvPr id="9" name="Gráfico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6363575"/>
              </p:ext>
            </p:extLst>
          </p:nvPr>
        </p:nvGraphicFramePr>
        <p:xfrm>
          <a:off x="509687" y="4309971"/>
          <a:ext cx="3638275" cy="2268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CuadroTexto 16"/>
          <p:cNvSpPr txBox="1"/>
          <p:nvPr/>
        </p:nvSpPr>
        <p:spPr>
          <a:xfrm>
            <a:off x="1473535" y="6372910"/>
            <a:ext cx="1630680" cy="2419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2" dirty="0" err="1">
                <a:latin typeface="Arial" panose="020B0604020202020204" pitchFamily="34" charset="0"/>
                <a:cs typeface="Arial" panose="020B0604020202020204" pitchFamily="34" charset="0"/>
              </a:rPr>
              <a:t>Elution</a:t>
            </a:r>
            <a:r>
              <a:rPr lang="es-ES" sz="972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72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es-ES" sz="972" dirty="0">
                <a:latin typeface="Arial" panose="020B0604020202020204" pitchFamily="34" charset="0"/>
                <a:cs typeface="Arial" panose="020B0604020202020204" pitchFamily="34" charset="0"/>
              </a:rPr>
              <a:t> (ml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866242" y="4052277"/>
            <a:ext cx="213115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3869401" y="6115628"/>
            <a:ext cx="2434742" cy="1099748"/>
            <a:chOff x="106534" y="19266307"/>
            <a:chExt cx="9516593" cy="4298549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3"/>
            <a:srcRect t="10360" b="59415"/>
            <a:stretch/>
          </p:blipFill>
          <p:spPr>
            <a:xfrm>
              <a:off x="2600404" y="20462742"/>
              <a:ext cx="1614311" cy="1304238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4"/>
            <a:srcRect b="64522"/>
            <a:stretch/>
          </p:blipFill>
          <p:spPr>
            <a:xfrm>
              <a:off x="3901078" y="20357196"/>
              <a:ext cx="3539067" cy="1409784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8156307" y="20737963"/>
              <a:ext cx="1404751" cy="839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Env</a:t>
              </a:r>
            </a:p>
          </p:txBody>
        </p:sp>
        <p:cxnSp>
          <p:nvCxnSpPr>
            <p:cNvPr id="17" name="Straight Arrow Connector 16"/>
            <p:cNvCxnSpPr/>
            <p:nvPr/>
          </p:nvCxnSpPr>
          <p:spPr>
            <a:xfrm flipH="1">
              <a:off x="7418953" y="21101412"/>
              <a:ext cx="737354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 rot="19406305">
              <a:off x="2604774" y="19266307"/>
              <a:ext cx="1999982" cy="839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5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RC01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9406305">
              <a:off x="3943230" y="19310197"/>
              <a:ext cx="1686699" cy="839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5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G12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9406305">
              <a:off x="5044035" y="19367659"/>
              <a:ext cx="1423544" cy="839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5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51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9406305">
              <a:off x="6011501" y="19322971"/>
              <a:ext cx="1962389" cy="839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5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4 </a:t>
              </a:r>
              <a:r>
                <a:rPr lang="en-US" sz="795" dirty="0" err="1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</a:t>
              </a:r>
              <a:endParaRPr lang="en-US" sz="795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06534" y="20679150"/>
              <a:ext cx="4228759" cy="8390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Precipitate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37600" y="22215901"/>
              <a:ext cx="4228759" cy="8390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Supernatant</a:t>
              </a: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5"/>
            <a:srcRect l="1" t="29392" r="4032" b="-1"/>
            <a:stretch/>
          </p:blipFill>
          <p:spPr>
            <a:xfrm>
              <a:off x="2600119" y="22300658"/>
              <a:ext cx="4880903" cy="1264198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8218376" y="22352352"/>
              <a:ext cx="1404751" cy="839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95" dirty="0">
                  <a:latin typeface="Arial" panose="020B0604020202020204" pitchFamily="34" charset="0"/>
                  <a:cs typeface="Arial" panose="020B0604020202020204" pitchFamily="34" charset="0"/>
                </a:rPr>
                <a:t>Env</a:t>
              </a: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 flipH="1">
              <a:off x="7481023" y="22715801"/>
              <a:ext cx="737354" cy="0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" name="TextBox 26"/>
          <p:cNvSpPr txBox="1"/>
          <p:nvPr/>
        </p:nvSpPr>
        <p:spPr>
          <a:xfrm>
            <a:off x="2491282" y="4045083"/>
            <a:ext cx="194207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347957" y="4051437"/>
            <a:ext cx="244509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9" name="Down Arrow 28"/>
          <p:cNvSpPr/>
          <p:nvPr/>
        </p:nvSpPr>
        <p:spPr>
          <a:xfrm>
            <a:off x="1412196" y="4276396"/>
            <a:ext cx="118196" cy="161200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40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Down Arrow 29"/>
          <p:cNvSpPr/>
          <p:nvPr/>
        </p:nvSpPr>
        <p:spPr>
          <a:xfrm>
            <a:off x="1938400" y="4280592"/>
            <a:ext cx="118196" cy="161200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40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Down Arrow 30"/>
          <p:cNvSpPr/>
          <p:nvPr/>
        </p:nvSpPr>
        <p:spPr>
          <a:xfrm>
            <a:off x="2561013" y="4262611"/>
            <a:ext cx="118196" cy="161200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40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571098" y="4051437"/>
            <a:ext cx="244509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4" name="Down Arrow 33"/>
          <p:cNvSpPr/>
          <p:nvPr/>
        </p:nvSpPr>
        <p:spPr>
          <a:xfrm>
            <a:off x="1648589" y="4276396"/>
            <a:ext cx="118196" cy="161200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40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Down Arrow 34"/>
          <p:cNvSpPr/>
          <p:nvPr/>
        </p:nvSpPr>
        <p:spPr>
          <a:xfrm>
            <a:off x="2277837" y="4274531"/>
            <a:ext cx="118196" cy="161200"/>
          </a:xfrm>
          <a:prstGeom prst="downArrow">
            <a:avLst/>
          </a:prstGeom>
          <a:solidFill>
            <a:schemeClr val="tx1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4403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211330" y="4051145"/>
            <a:ext cx="194207" cy="2717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6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676247" y="4023052"/>
            <a:ext cx="292068" cy="2717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6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9" name="CuadroTexto 16"/>
          <p:cNvSpPr txBox="1"/>
          <p:nvPr/>
        </p:nvSpPr>
        <p:spPr>
          <a:xfrm rot="16200000">
            <a:off x="-645865" y="5025546"/>
            <a:ext cx="2098559" cy="2419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72" dirty="0" err="1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lang="es-ES" sz="972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72" dirty="0" err="1">
                <a:latin typeface="Arial" panose="020B0604020202020204" pitchFamily="34" charset="0"/>
                <a:cs typeface="Arial" panose="020B0604020202020204" pitchFamily="34" charset="0"/>
              </a:rPr>
              <a:t>Luminescence</a:t>
            </a:r>
            <a:r>
              <a:rPr lang="es-ES" sz="972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72" dirty="0" err="1">
                <a:latin typeface="Arial" panose="020B0604020202020204" pitchFamily="34" charset="0"/>
                <a:cs typeface="Arial" panose="020B0604020202020204" pitchFamily="34" charset="0"/>
              </a:rPr>
              <a:t>Units</a:t>
            </a:r>
            <a:endParaRPr lang="es-ES" sz="97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3169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181</TotalTime>
  <Words>213</Words>
  <Application>Microsoft Office PowerPoint</Application>
  <PresentationFormat>Custom</PresentationFormat>
  <Paragraphs>10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ten Witt</dc:creator>
  <cp:lastModifiedBy>kristenwitt@outlook.com</cp:lastModifiedBy>
  <cp:revision>448</cp:revision>
  <dcterms:created xsi:type="dcterms:W3CDTF">2016-04-05T18:18:37Z</dcterms:created>
  <dcterms:modified xsi:type="dcterms:W3CDTF">2016-12-11T19:07:43Z</dcterms:modified>
</cp:coreProperties>
</file>